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E2FE90-3581-4129-86FF-039F59DE4F2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C1E58B-EB66-4430-A80D-02D99474AC4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253F44-DA57-45A5-AB60-88C17E6A285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6D0902-0E4B-485C-BF16-41EA6D03E8C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4CB0DC-F007-403F-9A3B-3459F70D012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0251A3-5D5C-420A-9990-798A029A491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E516A2-11CA-4415-905D-2ACC073E2B0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F3C9FF-9AE2-4F0B-A0E0-691E3D062FE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6064E6-B5CD-4C14-9CFF-93D6D893308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B9AF82-994E-4B7F-AC2B-10BA98C283D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9C3AE0-3ECB-4FB7-AD53-8AB62CF143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765E70-1BF9-4625-AAFF-7C6F4D1C025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4BFEE96-FBAC-4E65-B606-A60385732EF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hyperlink" Target="http://www.ncbi.nlm.nih.gov/entrez/query.fcgi?cmd=Retrieve&amp;db=PubMed&amp;list_uids=12424112&amp;dopt=Abstract" TargetMode="External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34"/>
          <p:cNvGrpSpPr/>
          <p:nvPr/>
        </p:nvGrpSpPr>
        <p:grpSpPr>
          <a:xfrm>
            <a:off x="306360" y="838080"/>
            <a:ext cx="8167680" cy="5529600"/>
            <a:chOff x="306360" y="838080"/>
            <a:chExt cx="8167680" cy="5529600"/>
          </a:xfrm>
        </p:grpSpPr>
        <p:grpSp>
          <p:nvGrpSpPr>
            <p:cNvPr id="42" name="Group 4"/>
            <p:cNvGrpSpPr/>
            <p:nvPr/>
          </p:nvGrpSpPr>
          <p:grpSpPr>
            <a:xfrm>
              <a:off x="930240" y="955440"/>
              <a:ext cx="7467480" cy="2410200"/>
              <a:chOff x="930240" y="955440"/>
              <a:chExt cx="7467480" cy="2410200"/>
            </a:xfrm>
          </p:grpSpPr>
          <p:grpSp>
            <p:nvGrpSpPr>
              <p:cNvPr id="43" name="Group 5"/>
              <p:cNvGrpSpPr/>
              <p:nvPr/>
            </p:nvGrpSpPr>
            <p:grpSpPr>
              <a:xfrm>
                <a:off x="930240" y="955440"/>
                <a:ext cx="7467480" cy="1447920"/>
                <a:chOff x="930240" y="955440"/>
                <a:chExt cx="7467480" cy="1447920"/>
              </a:xfrm>
            </p:grpSpPr>
            <p:pic>
              <p:nvPicPr>
                <p:cNvPr id="44" name="Picture 4" descr=""/>
                <p:cNvPicPr/>
                <p:nvPr/>
              </p:nvPicPr>
              <p:blipFill>
                <a:blip r:embed="rId1"/>
                <a:stretch/>
              </p:blipFill>
              <p:spPr>
                <a:xfrm>
                  <a:off x="930240" y="955440"/>
                  <a:ext cx="7467480" cy="144792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45" name="TextBox 6"/>
                <p:cNvSpPr/>
                <p:nvPr/>
              </p:nvSpPr>
              <p:spPr>
                <a:xfrm>
                  <a:off x="3523680" y="1031760"/>
                  <a:ext cx="243468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Times New Roman"/>
                      <a:ea typeface="SimSun"/>
                    </a:rPr>
                    <a:t>The CpG sites of </a:t>
                  </a:r>
                  <a:r>
                    <a:rPr b="1" lang="en-US" sz="1200" spc="-1" strike="noStrike">
                      <a:solidFill>
                        <a:srgbClr val="000000"/>
                      </a:solidFill>
                      <a:latin typeface="Times New Roman"/>
                    </a:rPr>
                    <a:t>CASP8</a:t>
                  </a:r>
                  <a:r>
                    <a:rPr b="1" lang="en-US" sz="1200" spc="-1" strike="noStrike">
                      <a:solidFill>
                        <a:srgbClr val="000000"/>
                      </a:solidFill>
                      <a:latin typeface="Times New Roman"/>
                      <a:ea typeface="SimSun"/>
                    </a:rPr>
                    <a:t> promoter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46" name="Line 8"/>
              <p:cNvSpPr/>
              <p:nvPr/>
            </p:nvSpPr>
            <p:spPr>
              <a:xfrm>
                <a:off x="1158840" y="2631960"/>
                <a:ext cx="304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Line 9"/>
              <p:cNvSpPr/>
              <p:nvPr/>
            </p:nvSpPr>
            <p:spPr>
              <a:xfrm flipH="1">
                <a:off x="7331040" y="2555640"/>
                <a:ext cx="3808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Rectangle 10"/>
              <p:cNvSpPr/>
              <p:nvPr/>
            </p:nvSpPr>
            <p:spPr>
              <a:xfrm>
                <a:off x="1773360" y="2479680"/>
                <a:ext cx="1842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</a:rPr>
                  <a:t>Bisulfite sequence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SimSun"/>
                  </a:rPr>
                  <a:t> region 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Line 11"/>
              <p:cNvSpPr/>
              <p:nvPr/>
            </p:nvSpPr>
            <p:spPr>
              <a:xfrm>
                <a:off x="1539720" y="2936880"/>
                <a:ext cx="3812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Line 12"/>
              <p:cNvSpPr/>
              <p:nvPr/>
            </p:nvSpPr>
            <p:spPr>
              <a:xfrm flipH="1">
                <a:off x="4053960" y="2936880"/>
                <a:ext cx="304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Text Box 13"/>
              <p:cNvSpPr/>
              <p:nvPr/>
            </p:nvSpPr>
            <p:spPr>
              <a:xfrm>
                <a:off x="2226600" y="2784240"/>
                <a:ext cx="913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SimSun"/>
                  </a:rPr>
                  <a:t>MSP regio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Line 14"/>
              <p:cNvSpPr/>
              <p:nvPr/>
            </p:nvSpPr>
            <p:spPr>
              <a:xfrm>
                <a:off x="1616040" y="3241440"/>
                <a:ext cx="3808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Line 15"/>
              <p:cNvSpPr/>
              <p:nvPr/>
            </p:nvSpPr>
            <p:spPr>
              <a:xfrm flipH="1">
                <a:off x="5501880" y="3241440"/>
                <a:ext cx="304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Text Box 16"/>
              <p:cNvSpPr/>
              <p:nvPr/>
            </p:nvSpPr>
            <p:spPr>
              <a:xfrm>
                <a:off x="2610360" y="3089160"/>
                <a:ext cx="22687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SimSun"/>
                  </a:rPr>
                  <a:t>Promoter methylation PCR regio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Line 17"/>
              <p:cNvSpPr/>
              <p:nvPr/>
            </p:nvSpPr>
            <p:spPr>
              <a:xfrm flipH="1">
                <a:off x="3978360" y="2631960"/>
                <a:ext cx="3808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Line 18"/>
              <p:cNvSpPr/>
              <p:nvPr/>
            </p:nvSpPr>
            <p:spPr>
              <a:xfrm>
                <a:off x="4282920" y="2631960"/>
                <a:ext cx="1526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Rectangle 19"/>
              <p:cNvSpPr/>
              <p:nvPr/>
            </p:nvSpPr>
            <p:spPr>
              <a:xfrm>
                <a:off x="4669200" y="2479680"/>
                <a:ext cx="1842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</a:rPr>
                  <a:t>Bisulfite sequence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SimSun"/>
                  </a:rPr>
                  <a:t> region 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8" name="Group 20"/>
            <p:cNvGrpSpPr/>
            <p:nvPr/>
          </p:nvGrpSpPr>
          <p:grpSpPr>
            <a:xfrm>
              <a:off x="1006560" y="4079880"/>
              <a:ext cx="7467480" cy="2287800"/>
              <a:chOff x="1006560" y="4079880"/>
              <a:chExt cx="7467480" cy="2287800"/>
            </a:xfrm>
          </p:grpSpPr>
          <p:grpSp>
            <p:nvGrpSpPr>
              <p:cNvPr id="59" name="Group 21"/>
              <p:cNvGrpSpPr/>
              <p:nvPr/>
            </p:nvGrpSpPr>
            <p:grpSpPr>
              <a:xfrm>
                <a:off x="1006560" y="4079880"/>
                <a:ext cx="7467480" cy="1423800"/>
                <a:chOff x="1006560" y="4079880"/>
                <a:chExt cx="7467480" cy="1423800"/>
              </a:xfrm>
            </p:grpSpPr>
            <p:pic>
              <p:nvPicPr>
                <p:cNvPr id="60" name="Picture 3" descr=""/>
                <p:cNvPicPr/>
                <p:nvPr/>
              </p:nvPicPr>
              <p:blipFill>
                <a:blip r:embed="rId2"/>
                <a:stretch/>
              </p:blipFill>
              <p:spPr>
                <a:xfrm>
                  <a:off x="1006560" y="4079880"/>
                  <a:ext cx="7467480" cy="142380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61" name="Text Box 23"/>
                <p:cNvSpPr/>
                <p:nvPr/>
              </p:nvSpPr>
              <p:spPr>
                <a:xfrm>
                  <a:off x="3446640" y="4155840"/>
                  <a:ext cx="24361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Times New Roman"/>
                      <a:ea typeface="SimSun"/>
                    </a:rPr>
                    <a:t>The CpG sites of maspin promoter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62" name="Line 24"/>
              <p:cNvSpPr/>
              <p:nvPr/>
            </p:nvSpPr>
            <p:spPr>
              <a:xfrm>
                <a:off x="4282920" y="5756040"/>
                <a:ext cx="3812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Line 25"/>
              <p:cNvSpPr/>
              <p:nvPr/>
            </p:nvSpPr>
            <p:spPr>
              <a:xfrm flipH="1">
                <a:off x="7407360" y="5756040"/>
                <a:ext cx="3808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Rectangle 26"/>
              <p:cNvSpPr/>
              <p:nvPr/>
            </p:nvSpPr>
            <p:spPr>
              <a:xfrm>
                <a:off x="5655600" y="5603760"/>
                <a:ext cx="913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SimSun"/>
                  </a:rPr>
                  <a:t>MSP regio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Line 27"/>
              <p:cNvSpPr/>
              <p:nvPr/>
            </p:nvSpPr>
            <p:spPr>
              <a:xfrm>
                <a:off x="5654520" y="6060960"/>
                <a:ext cx="3812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Line 28"/>
              <p:cNvSpPr/>
              <p:nvPr/>
            </p:nvSpPr>
            <p:spPr>
              <a:xfrm flipH="1">
                <a:off x="7864200" y="6060960"/>
                <a:ext cx="2286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Rectangle 29"/>
              <p:cNvSpPr/>
              <p:nvPr/>
            </p:nvSpPr>
            <p:spPr>
              <a:xfrm>
                <a:off x="6264360" y="5908680"/>
                <a:ext cx="159048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SimSun"/>
                  </a:rPr>
                  <a:t>Promoter methylation PCR regio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8" name="Text Box 32"/>
            <p:cNvSpPr/>
            <p:nvPr/>
          </p:nvSpPr>
          <p:spPr>
            <a:xfrm>
              <a:off x="306360" y="83808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SimSun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Text Box 33"/>
            <p:cNvSpPr/>
            <p:nvPr/>
          </p:nvSpPr>
          <p:spPr>
            <a:xfrm>
              <a:off x="321840" y="3851280"/>
              <a:ext cx="282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SimSun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"/>
          <p:cNvSpPr/>
          <p:nvPr/>
        </p:nvSpPr>
        <p:spPr>
          <a:xfrm>
            <a:off x="533520" y="2209680"/>
            <a:ext cx="7893000" cy="1739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S1. Promoter CpG sites of CASP8 and maspin and the primers covered regions. The CpG sites in CASP8 promoter (A) and maspin promoter (B) were identified by </a:t>
            </a:r>
            <a:r>
              <a:rPr b="0" lang="en-US" sz="1800" spc="-1" strike="noStrike" u="sng">
                <a:solidFill>
                  <a:srgbClr val="009999"/>
                </a:solidFill>
                <a:uFillTx/>
                <a:latin typeface="Arial"/>
                <a:hlinkClick r:id="rId1"/>
              </a:rPr>
              <a:t>MethPrimer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Software as described in methods section. The sequences covered regions of primers used for promoter methylation PCR, MSP and bisulfite sequencing of CASP8 and maspin were indicated in A and B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9-22T04:46:15Z</dcterms:created>
  <dc:creator>Yanyuan Wu</dc:creator>
  <dc:description/>
  <dc:language>en-US</dc:language>
  <cp:lastModifiedBy>Dr. Jay Vadgama</cp:lastModifiedBy>
  <dcterms:modified xsi:type="dcterms:W3CDTF">2010-02-03T00:35:05Z</dcterms:modified>
  <cp:revision>11</cp:revision>
  <dc:subject/>
  <dc:title>Slide 1</dc:title>
</cp:coreProperties>
</file>